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9" r:id="rId2"/>
  </p:sldIdLst>
  <p:sldSz cx="9144000" cy="6858000" type="screen4x3"/>
  <p:notesSz cx="6735763" cy="98663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9E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84" autoAdjust="0"/>
    <p:restoredTop sz="94660"/>
  </p:normalViewPr>
  <p:slideViewPr>
    <p:cSldViewPr>
      <p:cViewPr varScale="1">
        <p:scale>
          <a:sx n="113" d="100"/>
          <a:sy n="113" d="100"/>
        </p:scale>
        <p:origin x="-1080" y="-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960E48-7B3D-4662-8F7C-27EBB4BE3E0F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52C720-C2DA-4A05-8D4D-D505C707C3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8625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7462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3148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820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930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4182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6611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4781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7383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2421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01855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6675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2912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표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9773760"/>
              </p:ext>
            </p:extLst>
          </p:nvPr>
        </p:nvGraphicFramePr>
        <p:xfrm>
          <a:off x="251519" y="725298"/>
          <a:ext cx="8640961" cy="5574595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080121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512168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512168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512168">
                  <a:extLst>
                    <a:ext uri="{9D8B030D-6E8A-4147-A177-3AD203B41FA5}">
                      <a16:colId xmlns="" xmlns:a16="http://schemas.microsoft.com/office/drawing/2014/main" val="2453766506"/>
                    </a:ext>
                  </a:extLst>
                </a:gridCol>
                <a:gridCol w="1512168">
                  <a:extLst>
                    <a:ext uri="{9D8B030D-6E8A-4147-A177-3AD203B41FA5}">
                      <a16:colId xmlns="" xmlns:a16="http://schemas.microsoft.com/office/drawing/2014/main" val="916520675"/>
                    </a:ext>
                  </a:extLst>
                </a:gridCol>
                <a:gridCol w="1512168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561867"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apability</a:t>
                      </a:r>
                      <a:r>
                        <a:rPr lang="en-US" altLang="ko-KR" sz="14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%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Total Read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apped Read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Unique hit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Depth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ontrol1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5.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 panose="020B0604020202020204" pitchFamily="34" charset="0"/>
                        </a:rPr>
                        <a:t>34,782,60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26,235,55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6,712,27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/>
                        </a:rPr>
                        <a:t>56.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ontrol2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2.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 panose="020B0604020202020204" pitchFamily="34" charset="0"/>
                        </a:rPr>
                        <a:t>48,911,72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35,580,20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40,170,950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/>
                        </a:rPr>
                        <a:t>66.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495764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ontrol3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3.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 panose="020B0604020202020204" pitchFamily="34" charset="0"/>
                        </a:rPr>
                        <a:t>36,441,59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26,663,82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29,678,434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/>
                        </a:rPr>
                        <a:t>43.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A1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3.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 panose="020B0604020202020204" pitchFamily="34" charset="0"/>
                        </a:rPr>
                        <a:t>40,438,05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29,884,71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33,224,166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/>
                        </a:rPr>
                        <a:t>53.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A2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5.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 panose="020B0604020202020204" pitchFamily="34" charset="0"/>
                        </a:rPr>
                        <a:t>41,703,28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31,410,4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34,888,372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/>
                        </a:rPr>
                        <a:t>58.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A3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100" b="1" dirty="0"/>
                        <a:t>74.5</a:t>
                      </a:r>
                      <a:endParaRPr lang="ko-KR" altLang="en-US" sz="1100" b="1" dirty="0"/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 panose="020B0604020202020204" pitchFamily="34" charset="0"/>
                        </a:rPr>
                        <a:t>32,820,02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24,446,91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27,202,906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/>
                        </a:rPr>
                        <a:t>43.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49576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AT1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0.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 panose="020B0604020202020204" pitchFamily="34" charset="0"/>
                        </a:rPr>
                        <a:t>66,099,73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46,664,72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52,614,680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/>
                        </a:rPr>
                        <a:t>72.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AT2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4.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 panose="020B0604020202020204" pitchFamily="34" charset="0"/>
                        </a:rPr>
                        <a:t>61,215,10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45,311,70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50,329,296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/>
                        </a:rPr>
                        <a:t>96.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AT3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1.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 panose="020B0604020202020204" pitchFamily="34" charset="0"/>
                        </a:rPr>
                        <a:t>37,046,95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26,559,52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30,203,412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/>
                        </a:rPr>
                        <a:t>46.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CB1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4.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 panose="020B0604020202020204" pitchFamily="34" charset="0"/>
                        </a:rPr>
                        <a:t>32,539,09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24,114,93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26,834,300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/>
                        </a:rPr>
                        <a:t>41.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CB2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2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 panose="020B0604020202020204" pitchFamily="34" charset="0"/>
                        </a:rPr>
                        <a:t>45,694,22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33,111,57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37,244,706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/>
                        </a:rPr>
                        <a:t>54.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CB3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1.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 panose="020B0604020202020204" pitchFamily="34" charset="0"/>
                        </a:rPr>
                        <a:t>39,536,17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28,185,26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effectLst/>
                          <a:latin typeface="Arial" panose="020B0604020202020204" pitchFamily="34" charset="0"/>
                        </a:rPr>
                        <a:t>31,837,986 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>
                          <a:effectLst/>
                          <a:latin typeface="Arial"/>
                        </a:rPr>
                        <a:t>44.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3E5280A3-9AD8-4A95-9315-FEE5DD66D992}"/>
              </a:ext>
            </a:extLst>
          </p:cNvPr>
          <p:cNvSpPr txBox="1"/>
          <p:nvPr/>
        </p:nvSpPr>
        <p:spPr>
          <a:xfrm>
            <a:off x="2329438" y="153539"/>
            <a:ext cx="44973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smtClean="0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Table. </a:t>
            </a:r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Mapping summary of RRBS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3205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58</TotalTime>
  <Words>88</Words>
  <Application>Microsoft Office PowerPoint</Application>
  <PresentationFormat>화면 슬라이드 쇼(4:3)</PresentationFormat>
  <Paragraphs>78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AEHOKFRI</dc:creator>
  <cp:lastModifiedBy>Ryzen_JAEHO</cp:lastModifiedBy>
  <cp:revision>422</cp:revision>
  <cp:lastPrinted>2018-01-29T12:39:48Z</cp:lastPrinted>
  <dcterms:created xsi:type="dcterms:W3CDTF">2016-12-05T06:47:22Z</dcterms:created>
  <dcterms:modified xsi:type="dcterms:W3CDTF">2019-05-27T01:24:28Z</dcterms:modified>
</cp:coreProperties>
</file>